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15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14.jpeg" ContentType="image/jpeg"/>
  <Override PartName="/ppt/media/image8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537464D-FBE9-4977-B30B-E0ABEF0D5B04}" type="slidenum">
              <a:rPr b="0" lang="zh-TW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2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133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TW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" name="投影片編號版面配置區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5170B5C-83AD-4BB8-99E2-F741AC61DC80}" type="slidenum">
              <a:rPr b="0" lang="zh-TW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28515A-36AF-4AB8-9589-69DD4C5DCF1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8F5827-5EEA-4DF6-91A1-F3B21CA4DA8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EDE823-FAA4-45D5-88D3-F7518DDC9B5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844742-F17F-47DD-A0C9-6C80DBE909E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75E185-3C77-452E-8CBA-6267F35FF7B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F9F7EC-B820-45D6-8730-9BE927D1163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2D8824-3BFB-4A78-B667-132644CF0BA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753CC9-81BE-4761-96B0-52D00AA4887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645064-B2AB-4182-84E0-36900E465DA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9C2EA9-AAB5-4692-A934-9A68FAE0112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24F49B-26E8-4B54-8FB6-5C661CD7DF6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5908F8-B739-45BA-A7D9-B2D72423A1A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4EAD410-4808-4377-A032-8416ED832F63}" type="slidenum">
              <a:rPr b="0" lang="zh-TW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jpeg"/><Relationship Id="rId15" Type="http://schemas.openxmlformats.org/officeDocument/2006/relationships/image" Target="../media/image15.png"/><Relationship Id="rId16" Type="http://schemas.openxmlformats.org/officeDocument/2006/relationships/slideLayout" Target="../slideLayouts/slideLayout1.xml"/><Relationship Id="rId17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文字方塊 2"/>
          <p:cNvSpPr/>
          <p:nvPr/>
        </p:nvSpPr>
        <p:spPr>
          <a:xfrm>
            <a:off x="4930920" y="7920"/>
            <a:ext cx="191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Yeh_Supplementary Fig. S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文字方塊 36"/>
          <p:cNvSpPr/>
          <p:nvPr/>
        </p:nvSpPr>
        <p:spPr>
          <a:xfrm>
            <a:off x="1738440" y="2050920"/>
            <a:ext cx="304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0" name="Picture 104" descr="F:\The second paper progress(20140826)\20141107-1-actin.tif"/>
          <p:cNvPicPr/>
          <p:nvPr/>
        </p:nvPicPr>
        <p:blipFill>
          <a:blip r:embed="rId1"/>
          <a:srcRect l="6667" t="0" r="2449" b="0"/>
          <a:stretch/>
        </p:blipFill>
        <p:spPr>
          <a:xfrm>
            <a:off x="1897200" y="5492880"/>
            <a:ext cx="720720" cy="17928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51" name="Picture 105" descr="F:\The second paper progress(20140826)\20141107-10hif1a.tif"/>
          <p:cNvPicPr/>
          <p:nvPr/>
        </p:nvPicPr>
        <p:blipFill>
          <a:blip r:embed="rId2"/>
          <a:srcRect l="6667" t="0" r="2449" b="0"/>
          <a:stretch/>
        </p:blipFill>
        <p:spPr>
          <a:xfrm>
            <a:off x="1897200" y="4818240"/>
            <a:ext cx="720720" cy="17928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52" name="Picture 107" descr="F:\The second paper progress(20140826)\20141107-1-cuclin D1.tif"/>
          <p:cNvPicPr/>
          <p:nvPr/>
        </p:nvPicPr>
        <p:blipFill>
          <a:blip r:embed="rId3"/>
          <a:srcRect l="12335" t="0" r="2305" b="0"/>
          <a:stretch/>
        </p:blipFill>
        <p:spPr>
          <a:xfrm>
            <a:off x="1897200" y="5040360"/>
            <a:ext cx="720720" cy="17928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53" name="Picture 108" descr="F:\The second paper progress(20140826)\20141107-1-beta-catenin.tif"/>
          <p:cNvPicPr/>
          <p:nvPr/>
        </p:nvPicPr>
        <p:blipFill>
          <a:blip r:embed="rId4"/>
          <a:srcRect l="6667" t="0" r="2449" b="0"/>
          <a:stretch/>
        </p:blipFill>
        <p:spPr>
          <a:xfrm>
            <a:off x="1897200" y="5273640"/>
            <a:ext cx="720720" cy="17928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54" name="文字方塊 100"/>
          <p:cNvSpPr/>
          <p:nvPr/>
        </p:nvSpPr>
        <p:spPr>
          <a:xfrm>
            <a:off x="2595600" y="4751280"/>
            <a:ext cx="56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HIF-1</a:t>
            </a:r>
            <a:r>
              <a:rPr b="0" lang="en-US" sz="8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文字方塊 100"/>
          <p:cNvSpPr/>
          <p:nvPr/>
        </p:nvSpPr>
        <p:spPr>
          <a:xfrm>
            <a:off x="2595600" y="5226120"/>
            <a:ext cx="612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-cateni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文字方塊 100"/>
          <p:cNvSpPr/>
          <p:nvPr/>
        </p:nvSpPr>
        <p:spPr>
          <a:xfrm>
            <a:off x="2595600" y="4992840"/>
            <a:ext cx="716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Cyclin D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文字方塊 100"/>
          <p:cNvSpPr/>
          <p:nvPr/>
        </p:nvSpPr>
        <p:spPr>
          <a:xfrm>
            <a:off x="2595600" y="5454720"/>
            <a:ext cx="423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Acti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文字方塊 98"/>
          <p:cNvSpPr/>
          <p:nvPr/>
        </p:nvSpPr>
        <p:spPr>
          <a:xfrm>
            <a:off x="2595600" y="4492800"/>
            <a:ext cx="434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IFN-</a:t>
            </a:r>
            <a:r>
              <a:rPr b="0" lang="en-US" sz="8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  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文字方塊 99"/>
          <p:cNvSpPr/>
          <p:nvPr/>
        </p:nvSpPr>
        <p:spPr>
          <a:xfrm>
            <a:off x="1871640" y="4614840"/>
            <a:ext cx="16826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0      0      5    10     FH535 (</a:t>
            </a:r>
            <a:r>
              <a:rPr b="0" lang="en-US" sz="8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M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0" name="群組 6"/>
          <p:cNvGrpSpPr/>
          <p:nvPr/>
        </p:nvGrpSpPr>
        <p:grpSpPr>
          <a:xfrm>
            <a:off x="1965240" y="4454640"/>
            <a:ext cx="660600" cy="246240"/>
            <a:chOff x="1965240" y="4454640"/>
            <a:chExt cx="660600" cy="246240"/>
          </a:xfrm>
        </p:grpSpPr>
        <p:sp>
          <p:nvSpPr>
            <p:cNvPr id="61" name="文字方塊 59"/>
            <p:cNvSpPr/>
            <p:nvPr/>
          </p:nvSpPr>
          <p:spPr>
            <a:xfrm>
              <a:off x="2055600" y="4454640"/>
              <a:ext cx="216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文字方塊 59"/>
            <p:cNvSpPr/>
            <p:nvPr/>
          </p:nvSpPr>
          <p:spPr>
            <a:xfrm>
              <a:off x="2223720" y="4454640"/>
              <a:ext cx="216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直線接點 214"/>
            <p:cNvSpPr/>
            <p:nvPr/>
          </p:nvSpPr>
          <p:spPr>
            <a:xfrm>
              <a:off x="1965240" y="4576680"/>
              <a:ext cx="54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文字方塊 59"/>
            <p:cNvSpPr/>
            <p:nvPr/>
          </p:nvSpPr>
          <p:spPr>
            <a:xfrm>
              <a:off x="2409120" y="4454640"/>
              <a:ext cx="216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5" name="文字方塊 185"/>
          <p:cNvSpPr/>
          <p:nvPr/>
        </p:nvSpPr>
        <p:spPr>
          <a:xfrm>
            <a:off x="4611600" y="5129280"/>
            <a:ext cx="895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Active </a:t>
            </a:r>
            <a:r>
              <a:rPr b="0" lang="en-US" sz="8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-cateni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文字方塊 185"/>
          <p:cNvSpPr/>
          <p:nvPr/>
        </p:nvSpPr>
        <p:spPr>
          <a:xfrm>
            <a:off x="4611600" y="5353200"/>
            <a:ext cx="885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Acti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文字方塊 72"/>
          <p:cNvSpPr/>
          <p:nvPr/>
        </p:nvSpPr>
        <p:spPr>
          <a:xfrm>
            <a:off x="4611600" y="4917960"/>
            <a:ext cx="727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FH535 (</a:t>
            </a:r>
            <a:r>
              <a:rPr b="0" lang="en-US" sz="8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M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文字方塊 13"/>
          <p:cNvSpPr/>
          <p:nvPr/>
        </p:nvSpPr>
        <p:spPr>
          <a:xfrm>
            <a:off x="3427560" y="4897440"/>
            <a:ext cx="191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文字方塊 13"/>
          <p:cNvSpPr/>
          <p:nvPr/>
        </p:nvSpPr>
        <p:spPr>
          <a:xfrm>
            <a:off x="3614760" y="4902120"/>
            <a:ext cx="212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文字方塊 78"/>
          <p:cNvSpPr/>
          <p:nvPr/>
        </p:nvSpPr>
        <p:spPr>
          <a:xfrm>
            <a:off x="4611600" y="4754520"/>
            <a:ext cx="596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IFN-</a:t>
            </a:r>
            <a:r>
              <a:rPr b="0" lang="en-US" sz="8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文字方塊 13"/>
          <p:cNvSpPr/>
          <p:nvPr/>
        </p:nvSpPr>
        <p:spPr>
          <a:xfrm>
            <a:off x="3759120" y="4897440"/>
            <a:ext cx="360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2.5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文字方塊 13"/>
          <p:cNvSpPr/>
          <p:nvPr/>
        </p:nvSpPr>
        <p:spPr>
          <a:xfrm>
            <a:off x="3963960" y="4903920"/>
            <a:ext cx="289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5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文字方塊 13"/>
          <p:cNvSpPr/>
          <p:nvPr/>
        </p:nvSpPr>
        <p:spPr>
          <a:xfrm>
            <a:off x="4156200" y="4903920"/>
            <a:ext cx="414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1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文字方塊 13"/>
          <p:cNvSpPr/>
          <p:nvPr/>
        </p:nvSpPr>
        <p:spPr>
          <a:xfrm>
            <a:off x="4341960" y="4903920"/>
            <a:ext cx="414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2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5" name="Picture 38" descr="C:\Users\A\Desktop\DATA\20150105\3-TUBULIN.tif"/>
          <p:cNvPicPr/>
          <p:nvPr/>
        </p:nvPicPr>
        <p:blipFill>
          <a:blip r:embed="rId5"/>
          <a:stretch/>
        </p:blipFill>
        <p:spPr>
          <a:xfrm>
            <a:off x="3424320" y="5365800"/>
            <a:ext cx="1187280" cy="17928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76" name="Picture 39" descr="C:\Users\A\Desktop\DATA\20150105\3-BCL2.tif"/>
          <p:cNvPicPr/>
          <p:nvPr/>
        </p:nvPicPr>
        <p:blipFill>
          <a:blip r:embed="rId6"/>
          <a:stretch/>
        </p:blipFill>
        <p:spPr>
          <a:xfrm>
            <a:off x="3424320" y="5146560"/>
            <a:ext cx="1187280" cy="17964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77" name="文字方塊 150"/>
          <p:cNvSpPr/>
          <p:nvPr/>
        </p:nvSpPr>
        <p:spPr>
          <a:xfrm>
            <a:off x="3424320" y="5543640"/>
            <a:ext cx="16016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1     1.34    0.61   0.77  0.37   0.27      (Folds)  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78" name="群組 7"/>
          <p:cNvGrpSpPr/>
          <p:nvPr/>
        </p:nvGrpSpPr>
        <p:grpSpPr>
          <a:xfrm>
            <a:off x="3527280" y="4724280"/>
            <a:ext cx="1059120" cy="246240"/>
            <a:chOff x="3527280" y="4724280"/>
            <a:chExt cx="1059120" cy="246240"/>
          </a:xfrm>
        </p:grpSpPr>
        <p:sp>
          <p:nvSpPr>
            <p:cNvPr id="79" name="文字方塊 59"/>
            <p:cNvSpPr/>
            <p:nvPr/>
          </p:nvSpPr>
          <p:spPr>
            <a:xfrm>
              <a:off x="3613320" y="4724280"/>
              <a:ext cx="216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文字方塊 59"/>
            <p:cNvSpPr/>
            <p:nvPr/>
          </p:nvSpPr>
          <p:spPr>
            <a:xfrm>
              <a:off x="3797280" y="4724280"/>
              <a:ext cx="216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" name="直線接點 240"/>
            <p:cNvSpPr/>
            <p:nvPr/>
          </p:nvSpPr>
          <p:spPr>
            <a:xfrm>
              <a:off x="3527280" y="4862520"/>
              <a:ext cx="54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文字方塊 59"/>
            <p:cNvSpPr/>
            <p:nvPr/>
          </p:nvSpPr>
          <p:spPr>
            <a:xfrm>
              <a:off x="3982680" y="4724280"/>
              <a:ext cx="216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文字方塊 59"/>
            <p:cNvSpPr/>
            <p:nvPr/>
          </p:nvSpPr>
          <p:spPr>
            <a:xfrm>
              <a:off x="4190040" y="4724280"/>
              <a:ext cx="216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" name="文字方塊 59"/>
            <p:cNvSpPr/>
            <p:nvPr/>
          </p:nvSpPr>
          <p:spPr>
            <a:xfrm>
              <a:off x="4369680" y="4724280"/>
              <a:ext cx="216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85" name="文字方塊 36"/>
          <p:cNvSpPr/>
          <p:nvPr/>
        </p:nvSpPr>
        <p:spPr>
          <a:xfrm>
            <a:off x="1700280" y="3954600"/>
            <a:ext cx="277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文字方塊 36"/>
          <p:cNvSpPr/>
          <p:nvPr/>
        </p:nvSpPr>
        <p:spPr>
          <a:xfrm>
            <a:off x="3287880" y="3954600"/>
            <a:ext cx="32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D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Text Box 14"/>
          <p:cNvSpPr/>
          <p:nvPr/>
        </p:nvSpPr>
        <p:spPr>
          <a:xfrm>
            <a:off x="4010040" y="2879640"/>
            <a:ext cx="571320" cy="23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GSK3</a:t>
            </a:r>
            <a:r>
              <a:rPr b="0" lang="en-US" sz="8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800" spc="-1" strike="noStrike" baseline="-25000">
                <a:solidFill>
                  <a:srgbClr val="000000"/>
                </a:solidFill>
                <a:latin typeface="Calibri"/>
              </a:rPr>
              <a:t>S9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8" name="Picture 2" descr="C:\Users\A\Downloads\20140527_data\HA11.tif"/>
          <p:cNvPicPr/>
          <p:nvPr/>
        </p:nvPicPr>
        <p:blipFill>
          <a:blip r:embed="rId7">
            <a:lum bright="-10000"/>
          </a:blip>
          <a:stretch/>
        </p:blipFill>
        <p:spPr>
          <a:xfrm>
            <a:off x="3435480" y="3368520"/>
            <a:ext cx="593640" cy="18108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89" name="Picture 3" descr="C:\Users\A\Downloads\20140527_data\ACTIN.tif"/>
          <p:cNvPicPr/>
          <p:nvPr/>
        </p:nvPicPr>
        <p:blipFill>
          <a:blip r:embed="rId8">
            <a:lum bright="-10000"/>
          </a:blip>
          <a:stretch/>
        </p:blipFill>
        <p:spPr>
          <a:xfrm>
            <a:off x="3435480" y="3587760"/>
            <a:ext cx="593640" cy="18108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90" name="Picture 4" descr="C:\Users\A\Downloads\20140527_data\AKT.tif"/>
          <p:cNvPicPr/>
          <p:nvPr/>
        </p:nvPicPr>
        <p:blipFill>
          <a:blip r:embed="rId9">
            <a:lum bright="-10000"/>
          </a:blip>
          <a:stretch/>
        </p:blipFill>
        <p:spPr>
          <a:xfrm>
            <a:off x="3435480" y="2684520"/>
            <a:ext cx="593640" cy="18108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91" name="Picture 5" descr="C:\Users\A\Downloads\20140527_data\AKT-S473.tif"/>
          <p:cNvPicPr/>
          <p:nvPr/>
        </p:nvPicPr>
        <p:blipFill>
          <a:blip r:embed="rId10">
            <a:lum bright="-10000"/>
          </a:blip>
          <a:srcRect l="6540" t="5667" r="872" b="12167"/>
          <a:stretch/>
        </p:blipFill>
        <p:spPr>
          <a:xfrm>
            <a:off x="3427560" y="2460600"/>
            <a:ext cx="612720" cy="18108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92" name="Picture 6" descr="C:\Users\A\Downloads\20140527_data\GSK3B.tif"/>
          <p:cNvPicPr/>
          <p:nvPr/>
        </p:nvPicPr>
        <p:blipFill>
          <a:blip r:embed="rId11">
            <a:lum bright="-10000"/>
          </a:blip>
          <a:stretch/>
        </p:blipFill>
        <p:spPr>
          <a:xfrm>
            <a:off x="3435480" y="3135240"/>
            <a:ext cx="593640" cy="18108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93" name="Picture 7" descr="C:\Users\A\Downloads\20140527_data\GSK3B-S9.tif"/>
          <p:cNvPicPr/>
          <p:nvPr/>
        </p:nvPicPr>
        <p:blipFill>
          <a:blip r:embed="rId12">
            <a:lum bright="-10000"/>
          </a:blip>
          <a:srcRect l="0" t="0" r="0" b="-3024"/>
          <a:stretch/>
        </p:blipFill>
        <p:spPr>
          <a:xfrm>
            <a:off x="3435480" y="2909880"/>
            <a:ext cx="593640" cy="18432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94" name="文字方塊 16"/>
          <p:cNvSpPr/>
          <p:nvPr/>
        </p:nvSpPr>
        <p:spPr>
          <a:xfrm>
            <a:off x="4014720" y="2104920"/>
            <a:ext cx="495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IFN-</a:t>
            </a:r>
            <a:r>
              <a:rPr b="0" lang="en-US" sz="8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文字方塊 17"/>
          <p:cNvSpPr/>
          <p:nvPr/>
        </p:nvSpPr>
        <p:spPr>
          <a:xfrm>
            <a:off x="4005360" y="2249640"/>
            <a:ext cx="576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HA-PTE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Text Box 14"/>
          <p:cNvSpPr/>
          <p:nvPr/>
        </p:nvSpPr>
        <p:spPr>
          <a:xfrm>
            <a:off x="4005360" y="3562200"/>
            <a:ext cx="41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Acti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Text Box 14"/>
          <p:cNvSpPr/>
          <p:nvPr/>
        </p:nvSpPr>
        <p:spPr>
          <a:xfrm>
            <a:off x="4005360" y="2454120"/>
            <a:ext cx="566640" cy="23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AKT</a:t>
            </a:r>
            <a:r>
              <a:rPr b="0" lang="en-US" sz="800" spc="-1" strike="noStrike" baseline="-25000">
                <a:solidFill>
                  <a:srgbClr val="000000"/>
                </a:solidFill>
                <a:latin typeface="Calibri"/>
              </a:rPr>
              <a:t>S47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Text Box 14"/>
          <p:cNvSpPr/>
          <p:nvPr/>
        </p:nvSpPr>
        <p:spPr>
          <a:xfrm>
            <a:off x="4014720" y="2690640"/>
            <a:ext cx="381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AK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Text Box 14"/>
          <p:cNvSpPr/>
          <p:nvPr/>
        </p:nvSpPr>
        <p:spPr>
          <a:xfrm>
            <a:off x="4006800" y="3116160"/>
            <a:ext cx="503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GSK3</a:t>
            </a:r>
            <a:r>
              <a:rPr b="0" lang="en-US" sz="8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文字方塊 130"/>
          <p:cNvSpPr/>
          <p:nvPr/>
        </p:nvSpPr>
        <p:spPr>
          <a:xfrm>
            <a:off x="4002120" y="3330720"/>
            <a:ext cx="342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H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01" name="Picture 2" descr=""/>
          <p:cNvPicPr/>
          <p:nvPr/>
        </p:nvPicPr>
        <p:blipFill>
          <a:blip r:embed="rId13"/>
          <a:stretch/>
        </p:blipFill>
        <p:spPr>
          <a:xfrm>
            <a:off x="1881360" y="3152880"/>
            <a:ext cx="865080" cy="18072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102" name="Picture 3" descr=""/>
          <p:cNvPicPr/>
          <p:nvPr/>
        </p:nvPicPr>
        <p:blipFill>
          <a:blip r:embed="rId14"/>
          <a:stretch/>
        </p:blipFill>
        <p:spPr>
          <a:xfrm>
            <a:off x="1881360" y="3589200"/>
            <a:ext cx="865080" cy="17964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103" name="Picture 4" descr=""/>
          <p:cNvPicPr/>
          <p:nvPr/>
        </p:nvPicPr>
        <p:blipFill>
          <a:blip r:embed="rId15"/>
          <a:stretch/>
        </p:blipFill>
        <p:spPr>
          <a:xfrm>
            <a:off x="1881360" y="3370320"/>
            <a:ext cx="865080" cy="17928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104" name="文字方塊 9"/>
          <p:cNvSpPr/>
          <p:nvPr/>
        </p:nvSpPr>
        <p:spPr>
          <a:xfrm>
            <a:off x="2730600" y="3567240"/>
            <a:ext cx="444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Acti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文字方塊 13"/>
          <p:cNvSpPr/>
          <p:nvPr/>
        </p:nvSpPr>
        <p:spPr>
          <a:xfrm>
            <a:off x="2730600" y="3344760"/>
            <a:ext cx="444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STAT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文字方塊 15"/>
          <p:cNvSpPr/>
          <p:nvPr/>
        </p:nvSpPr>
        <p:spPr>
          <a:xfrm>
            <a:off x="2739960" y="2948040"/>
            <a:ext cx="569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si-STAT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文字方塊 33"/>
          <p:cNvSpPr/>
          <p:nvPr/>
        </p:nvSpPr>
        <p:spPr>
          <a:xfrm>
            <a:off x="2744640" y="2647800"/>
            <a:ext cx="43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IFN-</a:t>
            </a:r>
            <a:r>
              <a:rPr b="0" lang="en-US" sz="8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文字方塊 34"/>
          <p:cNvSpPr/>
          <p:nvPr/>
        </p:nvSpPr>
        <p:spPr>
          <a:xfrm>
            <a:off x="2738520" y="2813040"/>
            <a:ext cx="361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DFX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文字方塊 131"/>
          <p:cNvSpPr/>
          <p:nvPr/>
        </p:nvSpPr>
        <p:spPr>
          <a:xfrm>
            <a:off x="2732040" y="3108240"/>
            <a:ext cx="527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HIF-1</a:t>
            </a:r>
            <a:r>
              <a:rPr b="0" lang="en-US" sz="8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lang="en-US" sz="800" spc="-1" strike="noStrike">
                <a:solidFill>
                  <a:srgbClr val="000000"/>
                </a:solidFill>
                <a:latin typeface="Trebuchet MS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直線接點 153"/>
          <p:cNvSpPr/>
          <p:nvPr/>
        </p:nvSpPr>
        <p:spPr>
          <a:xfrm>
            <a:off x="1965240" y="2765520"/>
            <a:ext cx="5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直線接點 157"/>
          <p:cNvSpPr/>
          <p:nvPr/>
        </p:nvSpPr>
        <p:spPr>
          <a:xfrm>
            <a:off x="1965240" y="2909880"/>
            <a:ext cx="5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文字方塊 59"/>
          <p:cNvSpPr/>
          <p:nvPr/>
        </p:nvSpPr>
        <p:spPr>
          <a:xfrm>
            <a:off x="2022480" y="2635200"/>
            <a:ext cx="217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直線接點 159"/>
          <p:cNvSpPr/>
          <p:nvPr/>
        </p:nvSpPr>
        <p:spPr>
          <a:xfrm>
            <a:off x="2441520" y="2765520"/>
            <a:ext cx="5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文字方塊 59"/>
          <p:cNvSpPr/>
          <p:nvPr/>
        </p:nvSpPr>
        <p:spPr>
          <a:xfrm>
            <a:off x="2192400" y="2635200"/>
            <a:ext cx="217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直線接點 161"/>
          <p:cNvSpPr/>
          <p:nvPr/>
        </p:nvSpPr>
        <p:spPr>
          <a:xfrm>
            <a:off x="2608200" y="2765520"/>
            <a:ext cx="5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直線接點 170"/>
          <p:cNvSpPr/>
          <p:nvPr/>
        </p:nvSpPr>
        <p:spPr>
          <a:xfrm>
            <a:off x="2116080" y="2909880"/>
            <a:ext cx="5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" name="直線接點 171"/>
          <p:cNvSpPr/>
          <p:nvPr/>
        </p:nvSpPr>
        <p:spPr>
          <a:xfrm>
            <a:off x="2284560" y="2909880"/>
            <a:ext cx="5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直線接點 172"/>
          <p:cNvSpPr/>
          <p:nvPr/>
        </p:nvSpPr>
        <p:spPr>
          <a:xfrm>
            <a:off x="1965240" y="3062160"/>
            <a:ext cx="5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直線接點 173"/>
          <p:cNvSpPr/>
          <p:nvPr/>
        </p:nvSpPr>
        <p:spPr>
          <a:xfrm>
            <a:off x="2116080" y="3062160"/>
            <a:ext cx="5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直線接點 174"/>
          <p:cNvSpPr/>
          <p:nvPr/>
        </p:nvSpPr>
        <p:spPr>
          <a:xfrm>
            <a:off x="2441520" y="3062160"/>
            <a:ext cx="5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" name="文字方塊 59"/>
          <p:cNvSpPr/>
          <p:nvPr/>
        </p:nvSpPr>
        <p:spPr>
          <a:xfrm>
            <a:off x="2349360" y="2784600"/>
            <a:ext cx="217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" name="文字方塊 59"/>
          <p:cNvSpPr/>
          <p:nvPr/>
        </p:nvSpPr>
        <p:spPr>
          <a:xfrm>
            <a:off x="2517840" y="2784600"/>
            <a:ext cx="217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" name="文字方塊 59"/>
          <p:cNvSpPr/>
          <p:nvPr/>
        </p:nvSpPr>
        <p:spPr>
          <a:xfrm>
            <a:off x="2192400" y="2932200"/>
            <a:ext cx="217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" name="文字方塊 59"/>
          <p:cNvSpPr/>
          <p:nvPr/>
        </p:nvSpPr>
        <p:spPr>
          <a:xfrm>
            <a:off x="2517840" y="2932200"/>
            <a:ext cx="217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" name="直線接點 179"/>
          <p:cNvSpPr/>
          <p:nvPr/>
        </p:nvSpPr>
        <p:spPr>
          <a:xfrm>
            <a:off x="3527280" y="2206800"/>
            <a:ext cx="5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" name="文字方塊 59"/>
          <p:cNvSpPr/>
          <p:nvPr/>
        </p:nvSpPr>
        <p:spPr>
          <a:xfrm>
            <a:off x="3635280" y="2076480"/>
            <a:ext cx="217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" name="文字方塊 59"/>
          <p:cNvSpPr/>
          <p:nvPr/>
        </p:nvSpPr>
        <p:spPr>
          <a:xfrm>
            <a:off x="3813120" y="2076480"/>
            <a:ext cx="217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" name="直線接點 182"/>
          <p:cNvSpPr/>
          <p:nvPr/>
        </p:nvSpPr>
        <p:spPr>
          <a:xfrm>
            <a:off x="3527280" y="2363760"/>
            <a:ext cx="5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直線接點 183"/>
          <p:cNvSpPr/>
          <p:nvPr/>
        </p:nvSpPr>
        <p:spPr>
          <a:xfrm>
            <a:off x="3720960" y="2363760"/>
            <a:ext cx="5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" name="文字方塊 59"/>
          <p:cNvSpPr/>
          <p:nvPr/>
        </p:nvSpPr>
        <p:spPr>
          <a:xfrm>
            <a:off x="3813120" y="2233440"/>
            <a:ext cx="217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" name="文字方塊 36"/>
          <p:cNvSpPr/>
          <p:nvPr/>
        </p:nvSpPr>
        <p:spPr>
          <a:xfrm>
            <a:off x="3125880" y="2050920"/>
            <a:ext cx="303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7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9-08T07:00:22Z</dcterms:created>
  <dc:creator>yeh</dc:creator>
  <dc:description/>
  <dc:language>en-US</dc:language>
  <cp:lastModifiedBy>Abella, Jerard Dave</cp:lastModifiedBy>
  <dcterms:modified xsi:type="dcterms:W3CDTF">2018-03-13T10:51:58Z</dcterms:modified>
  <cp:revision>24</cp:revision>
  <dc:subject/>
  <dc:title>PowerPoint 簡報</dc:title>
</cp:coreProperties>
</file>